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34692-D8AD-4E8D-A700-6C0BB598E8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85493-80BD-4621-B7EA-EAD49557D2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343CB-EAF2-4C23-A4C9-22DC3BB22C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72AD4B-C421-4A91-9BD4-F7453B068A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186A8-ED5E-4236-897A-133C14A269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E16DD-BA1B-4721-9A16-7C5AD1A40C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7518C-1C62-4286-9FF8-CFB6F85145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3DC00-C926-4EB8-A963-D897C4C4BF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4C1BB-DAA3-44C1-97E1-E6A19B8875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4894E-13CC-48CA-836F-A7693A830C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B5E52-462B-4575-9566-C645FBB5F0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0FB20-F206-47DD-A0E5-88C29F5308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FC9813-1757-409F-991D-1D623DE28B0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266840" y="2021040"/>
          <a:ext cx="10515600" cy="2593800"/>
        </p:xfrm>
        <a:graphic>
          <a:graphicData uri="http://schemas.openxmlformats.org/drawingml/2006/table">
            <a:tbl>
              <a:tblPr/>
              <a:tblGrid>
                <a:gridCol w="650880"/>
                <a:gridCol w="469800"/>
                <a:gridCol w="470160"/>
                <a:gridCol w="469800"/>
                <a:gridCol w="468360"/>
                <a:gridCol w="469800"/>
                <a:gridCol w="469800"/>
                <a:gridCol w="469800"/>
                <a:gridCol w="470160"/>
                <a:gridCol w="469800"/>
                <a:gridCol w="469800"/>
                <a:gridCol w="470160"/>
                <a:gridCol w="469800"/>
                <a:gridCol w="469800"/>
                <a:gridCol w="469800"/>
                <a:gridCol w="468360"/>
                <a:gridCol w="470160"/>
                <a:gridCol w="469800"/>
                <a:gridCol w="469800"/>
                <a:gridCol w="469800"/>
                <a:gridCol w="470160"/>
                <a:gridCol w="469800"/>
              </a:tblGrid>
              <a:tr h="369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HS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HS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HS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.31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.31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.31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.24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.24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.24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24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24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24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starv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starv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.starv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.14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.14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.14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.6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.6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.6-3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WA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e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d087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ca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d087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c2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c6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c9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e9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9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d68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c78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f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c6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c88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d087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cd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WA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cb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489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ca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d48a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d389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69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cd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d087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c5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c9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d88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494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f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c8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b8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d389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CL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c37e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CL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bf7c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iwi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cc84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c8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c6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c5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c78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c9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c580"/>
                    </a:solidFill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iwi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c5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c78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c5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37f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iwi0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58a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c9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d8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cf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d389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cb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e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c982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c78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c2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c2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c4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c2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c5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e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c57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iwi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2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e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c17d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bf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c0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c17d"/>
                    </a:solidFill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iwi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ce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f9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29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b8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cb84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cd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cc84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f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c9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e998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d68b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c8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d288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a8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d9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d087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cb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d288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d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ce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ca83"/>
                    </a:solidFill>
                  </a:tcPr>
                </a:tc>
              </a:tr>
              <a:tr h="185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iwi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c881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49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58a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d389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c3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bf7c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c6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6c982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c27e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c8f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fcb84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f86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cb84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ca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d187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ca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dc680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ce85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ca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ca83"/>
                    </a:solidFill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c47f"/>
                    </a:solidFill>
                  </a:tcPr>
                </a:tc>
              </a:tr>
            </a:tbl>
          </a:graphicData>
        </a:graphic>
      </p:graphicFrame>
      <p:sp>
        <p:nvSpPr>
          <p:cNvPr id="42" name="Runde Klammer links 5"/>
          <p:cNvSpPr/>
          <p:nvPr/>
        </p:nvSpPr>
        <p:spPr>
          <a:xfrm>
            <a:off x="1144440" y="2619360"/>
            <a:ext cx="173160" cy="276120"/>
          </a:xfrm>
          <a:custGeom>
            <a:avLst/>
            <a:gdLst>
              <a:gd name="textAreaLeft" fmla="*/ 50760 w 173160"/>
              <a:gd name="textAreaRight" fmla="*/ 173520 w 173160"/>
              <a:gd name="textAreaTop" fmla="*/ 7200 h 276120"/>
              <a:gd name="textAreaBottom" fmla="*/ 268920 h 2761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63"/>
                  <a:pt x="0" y="1126"/>
                </a:cubicBezTo>
                <a:lnTo>
                  <a:pt x="0" y="20474"/>
                </a:lnTo>
                <a:cubicBezTo>
                  <a:pt x="0" y="21037"/>
                  <a:pt x="10800" y="21600"/>
                  <a:pt x="2160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feld 7"/>
          <p:cNvSpPr/>
          <p:nvPr/>
        </p:nvSpPr>
        <p:spPr>
          <a:xfrm>
            <a:off x="363240" y="2556000"/>
            <a:ext cx="685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Early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Indu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unde Klammer links 9"/>
          <p:cNvSpPr/>
          <p:nvPr/>
        </p:nvSpPr>
        <p:spPr>
          <a:xfrm>
            <a:off x="1144440" y="2995560"/>
            <a:ext cx="173160" cy="868320"/>
          </a:xfrm>
          <a:custGeom>
            <a:avLst/>
            <a:gdLst>
              <a:gd name="textAreaLeft" fmla="*/ 50760 w 173160"/>
              <a:gd name="textAreaRight" fmla="*/ 173520 w 173160"/>
              <a:gd name="textAreaTop" fmla="*/ 7200 h 868320"/>
              <a:gd name="textAreaBottom" fmla="*/ 861120 h 868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180"/>
                  <a:pt x="0" y="359"/>
                </a:cubicBezTo>
                <a:lnTo>
                  <a:pt x="0" y="21241"/>
                </a:lnTo>
                <a:cubicBezTo>
                  <a:pt x="0" y="21421"/>
                  <a:pt x="10800" y="21600"/>
                  <a:pt x="2160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unde Klammer links 10"/>
          <p:cNvSpPr/>
          <p:nvPr/>
        </p:nvSpPr>
        <p:spPr>
          <a:xfrm>
            <a:off x="1144440" y="3941640"/>
            <a:ext cx="173160" cy="276480"/>
          </a:xfrm>
          <a:custGeom>
            <a:avLst/>
            <a:gdLst>
              <a:gd name="textAreaLeft" fmla="*/ 50760 w 173160"/>
              <a:gd name="textAreaRight" fmla="*/ 173520 w 173160"/>
              <a:gd name="textAreaTop" fmla="*/ 7200 h 276480"/>
              <a:gd name="textAreaBottom" fmla="*/ 269280 h 2764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63"/>
                  <a:pt x="0" y="1126"/>
                </a:cubicBezTo>
                <a:lnTo>
                  <a:pt x="0" y="20474"/>
                </a:lnTo>
                <a:cubicBezTo>
                  <a:pt x="0" y="21037"/>
                  <a:pt x="10800" y="21600"/>
                  <a:pt x="2160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unde Klammer links 11"/>
          <p:cNvSpPr/>
          <p:nvPr/>
        </p:nvSpPr>
        <p:spPr>
          <a:xfrm>
            <a:off x="1144440" y="4297320"/>
            <a:ext cx="173160" cy="277920"/>
          </a:xfrm>
          <a:custGeom>
            <a:avLst/>
            <a:gdLst>
              <a:gd name="textAreaLeft" fmla="*/ 50760 w 173160"/>
              <a:gd name="textAreaRight" fmla="*/ 173520 w 173160"/>
              <a:gd name="textAreaTop" fmla="*/ 7200 h 277920"/>
              <a:gd name="textAreaBottom" fmla="*/ 270720 h 277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63"/>
                  <a:pt x="0" y="1126"/>
                </a:cubicBezTo>
                <a:lnTo>
                  <a:pt x="0" y="20474"/>
                </a:lnTo>
                <a:cubicBezTo>
                  <a:pt x="0" y="21037"/>
                  <a:pt x="10800" y="21600"/>
                  <a:pt x="2160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feld 12"/>
          <p:cNvSpPr/>
          <p:nvPr/>
        </p:nvSpPr>
        <p:spPr>
          <a:xfrm>
            <a:off x="379800" y="3218040"/>
            <a:ext cx="468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Early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Peak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feld 13"/>
          <p:cNvSpPr/>
          <p:nvPr/>
        </p:nvSpPr>
        <p:spPr>
          <a:xfrm>
            <a:off x="324000" y="3879720"/>
            <a:ext cx="874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Intermediat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Indu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feld 14"/>
          <p:cNvSpPr/>
          <p:nvPr/>
        </p:nvSpPr>
        <p:spPr>
          <a:xfrm>
            <a:off x="322560" y="4259160"/>
            <a:ext cx="685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Late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Indu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06T11:02:48Z</dcterms:created>
  <dc:creator>Admin</dc:creator>
  <dc:description/>
  <dc:language>en-US</dc:language>
  <cp:lastModifiedBy>Admin</cp:lastModifiedBy>
  <dcterms:modified xsi:type="dcterms:W3CDTF">2015-04-06T16:18:50Z</dcterms:modified>
  <cp:revision>4</cp:revision>
  <dc:subject/>
  <dc:title>PowerPoint-Präsentation</dc:title>
</cp:coreProperties>
</file>